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109" d="100"/>
          <a:sy n="109" d="100"/>
        </p:scale>
        <p:origin x="-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252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3870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21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9788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7441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2969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725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906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74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0518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550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91F7B-6844-43CA-B113-58D6CEAE01C5}" type="datetimeFigureOut">
              <a:rPr kumimoji="1" lang="ja-JP" altLang="en-US" smtClean="0"/>
              <a:t>2017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3E1B6-5C46-4C5E-8557-0ED9E06FED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6350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oncomintan drug (POD _ 31)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1750" y="2482920"/>
            <a:ext cx="4000500" cy="408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954000" y="346875"/>
            <a:ext cx="7236000" cy="176400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ja-JP" kern="10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dditional file </a:t>
            </a: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endParaRPr lang="ja-JP" altLang="ja-JP" sz="1400" kern="100" dirty="0" smtClean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kern="100" dirty="0" smtClean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ultiple comparison of delta AUC between three groups classified according to concomitant drug usage (POD &lt; 31).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59147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CU</dc:creator>
  <cp:lastModifiedBy>Balindan, Danica Joy</cp:lastModifiedBy>
  <cp:revision>3</cp:revision>
  <dcterms:created xsi:type="dcterms:W3CDTF">2017-01-05T06:51:16Z</dcterms:created>
  <dcterms:modified xsi:type="dcterms:W3CDTF">2017-06-19T14:45:47Z</dcterms:modified>
</cp:coreProperties>
</file>